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737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721"/>
  </p:normalViewPr>
  <p:slideViewPr>
    <p:cSldViewPr snapToGrid="0" snapToObjects="1">
      <p:cViewPr>
        <p:scale>
          <a:sx n="141" d="100"/>
          <a:sy n="141" d="100"/>
        </p:scale>
        <p:origin x="180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62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224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66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616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934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110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64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852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377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992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993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87EF-891E-CC4E-9A8E-F51B8EDB9F5A}" type="datetimeFigureOut">
              <a:rPr lang="en-US" smtClean="0"/>
              <a:t>8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E573A-8136-E246-B1F2-015E3508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514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E7BCD8D2-AF3C-F54F-8B58-54C2205F3759}"/>
              </a:ext>
            </a:extLst>
          </p:cNvPr>
          <p:cNvSpPr txBox="1"/>
          <p:nvPr/>
        </p:nvSpPr>
        <p:spPr>
          <a:xfrm>
            <a:off x="208463" y="2649340"/>
            <a:ext cx="644107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rther characterization of the two subsets in cDC1 with high (S1) and low MFI (S2) in dextran-FITC uptake in terms of the expression of CD172a and MHC-II. Green histogram represents the subset S1 with high MFI, red histogram represents the subset S2 with low MFI.</a:t>
            </a:r>
            <a:endParaRPr lang="en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590E836-D4F6-B543-9DFE-549C9F6FDD4D}"/>
              </a:ext>
            </a:extLst>
          </p:cNvPr>
          <p:cNvGrpSpPr/>
          <p:nvPr/>
        </p:nvGrpSpPr>
        <p:grpSpPr>
          <a:xfrm>
            <a:off x="542541" y="779989"/>
            <a:ext cx="5897672" cy="1364394"/>
            <a:chOff x="711312" y="454869"/>
            <a:chExt cx="5897672" cy="1364394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50360703-141B-BD44-B1A0-D96930674D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64577" y="701090"/>
              <a:ext cx="1577074" cy="1118171"/>
            </a:xfrm>
            <a:prstGeom prst="rect">
              <a:avLst/>
            </a:prstGeom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F550E98D-FAF2-D14D-BCDD-DBC81744521B}"/>
                </a:ext>
              </a:extLst>
            </p:cNvPr>
            <p:cNvGrpSpPr/>
            <p:nvPr/>
          </p:nvGrpSpPr>
          <p:grpSpPr>
            <a:xfrm>
              <a:off x="711312" y="701092"/>
              <a:ext cx="1577074" cy="1118171"/>
              <a:chOff x="711312" y="701092"/>
              <a:chExt cx="1577074" cy="1118171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848D47AE-C728-A24F-A63B-0066E6A45F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11312" y="701092"/>
                <a:ext cx="1577074" cy="1118171"/>
              </a:xfrm>
              <a:prstGeom prst="rect">
                <a:avLst/>
              </a:prstGeom>
            </p:spPr>
          </p:pic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C0A43DDC-7201-2A46-8F7B-C881486005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76647" y="1345679"/>
                <a:ext cx="157778" cy="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E515C465-D113-EC4F-A1B5-F6474FC016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89907" y="1023376"/>
                <a:ext cx="150041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7BA29EE-DB68-3F43-84AC-CBB96A494155}"/>
                  </a:ext>
                </a:extLst>
              </p:cNvPr>
              <p:cNvSpPr txBox="1"/>
              <p:nvPr/>
            </p:nvSpPr>
            <p:spPr>
              <a:xfrm>
                <a:off x="1865770" y="1206051"/>
                <a:ext cx="3193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1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BA028CC-107D-5C4F-8BFC-264CE06DED39}"/>
                  </a:ext>
                </a:extLst>
              </p:cNvPr>
              <p:cNvSpPr txBox="1"/>
              <p:nvPr/>
            </p:nvSpPr>
            <p:spPr>
              <a:xfrm>
                <a:off x="1674762" y="875022"/>
                <a:ext cx="3193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2</a:t>
                </a:r>
              </a:p>
            </p:txBody>
          </p:sp>
        </p:grp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7F2F8C2-B0A5-5049-830A-C24443807C7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92542" y="701091"/>
              <a:ext cx="1577074" cy="1118171"/>
            </a:xfrm>
            <a:prstGeom prst="rect">
              <a:avLst/>
            </a:prstGeom>
          </p:spPr>
        </p:pic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AF0238BF-E967-CE4B-BD38-C8335CF5861A}"/>
                </a:ext>
              </a:extLst>
            </p:cNvPr>
            <p:cNvCxnSpPr>
              <a:cxnSpLocks/>
            </p:cNvCxnSpPr>
            <p:nvPr/>
          </p:nvCxnSpPr>
          <p:spPr>
            <a:xfrm>
              <a:off x="2452614" y="1206051"/>
              <a:ext cx="250913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C2C5538-BF4C-B64E-8E0F-5113B0B3159C}"/>
                </a:ext>
              </a:extLst>
            </p:cNvPr>
            <p:cNvSpPr txBox="1"/>
            <p:nvPr/>
          </p:nvSpPr>
          <p:spPr>
            <a:xfrm>
              <a:off x="3464150" y="454869"/>
              <a:ext cx="6270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72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29B13E9-A7F0-C34A-AD2A-28F3587532C2}"/>
                </a:ext>
              </a:extLst>
            </p:cNvPr>
            <p:cNvSpPr txBox="1"/>
            <p:nvPr/>
          </p:nvSpPr>
          <p:spPr>
            <a:xfrm>
              <a:off x="5132353" y="454869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II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D9602947-A190-3C4C-BCF0-8C2CE7528FEB}"/>
                </a:ext>
              </a:extLst>
            </p:cNvPr>
            <p:cNvGrpSpPr/>
            <p:nvPr/>
          </p:nvGrpSpPr>
          <p:grpSpPr>
            <a:xfrm>
              <a:off x="6116544" y="1078677"/>
              <a:ext cx="492440" cy="383754"/>
              <a:chOff x="6112797" y="1080199"/>
              <a:chExt cx="492440" cy="383754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8869B092-4F49-014C-8A33-BA5F8A76FB78}"/>
                  </a:ext>
                </a:extLst>
              </p:cNvPr>
              <p:cNvSpPr txBox="1"/>
              <p:nvPr/>
            </p:nvSpPr>
            <p:spPr>
              <a:xfrm>
                <a:off x="6311567" y="1248509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n>
                      <a:solidFill>
                        <a:srgbClr val="C00000"/>
                      </a:solidFill>
                    </a:ln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2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071AD22-B18B-F74B-B09B-4F20A010C9C4}"/>
                  </a:ext>
                </a:extLst>
              </p:cNvPr>
              <p:cNvSpPr txBox="1"/>
              <p:nvPr/>
            </p:nvSpPr>
            <p:spPr>
              <a:xfrm>
                <a:off x="6311567" y="1080199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1</a:t>
                </a: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7B53D130-836C-B947-8EC9-1FC3F901993A}"/>
                  </a:ext>
                </a:extLst>
              </p:cNvPr>
              <p:cNvSpPr/>
              <p:nvPr/>
            </p:nvSpPr>
            <p:spPr>
              <a:xfrm>
                <a:off x="6112797" y="1189618"/>
                <a:ext cx="216000" cy="28800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n>
                    <a:solidFill>
                      <a:srgbClr val="00B050"/>
                    </a:solidFill>
                  </a:ln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C5228699-3456-0647-8F1F-B158E8CC61F3}"/>
                  </a:ext>
                </a:extLst>
              </p:cNvPr>
              <p:cNvSpPr/>
              <p:nvPr/>
            </p:nvSpPr>
            <p:spPr>
              <a:xfrm>
                <a:off x="6112797" y="1353020"/>
                <a:ext cx="216000" cy="28800"/>
              </a:xfrm>
              <a:prstGeom prst="rect">
                <a:avLst/>
              </a:prstGeom>
              <a:solidFill>
                <a:srgbClr val="C00000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246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62</Words>
  <Application>Microsoft Macintosh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li Li</dc:creator>
  <cp:lastModifiedBy>Yanli Li</cp:lastModifiedBy>
  <cp:revision>7</cp:revision>
  <dcterms:created xsi:type="dcterms:W3CDTF">2020-04-19T23:56:11Z</dcterms:created>
  <dcterms:modified xsi:type="dcterms:W3CDTF">2020-08-04T12:12:09Z</dcterms:modified>
</cp:coreProperties>
</file>